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73E7D-B1ED-4A36-A3D6-C112AB5AE0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C2954-44CD-430C-A796-FF66FB62B2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A568D-4020-4153-8848-EB98075047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2A9E1-7F25-4ADF-878A-A88788F17C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B1DBE-47A3-482A-99B2-5B6FD6DB0B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5CE7A-E19E-4857-BB33-A17945393A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84C18-A8C2-4FC1-8400-50AA2C54C5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8D0DE-024F-49D4-AFC2-730374B57D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1A93B-5F22-4F74-B30C-3669551A52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A8D4C-21BF-4792-BAC1-4572F07B92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0A415-8009-44DE-A1F6-FBBB05AAF3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A3B1D-DA17-4E5F-83A4-5A654EE926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C626E9-CF06-4DE1-AEAF-4ACE0E0E757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609480" y="228600"/>
            <a:ext cx="8077320" cy="12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1 :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Quantitative segregation of dispersed cells based on budding patterns and morphology in the three different media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Table 2" descr=""/>
          <p:cNvPicPr/>
          <p:nvPr/>
        </p:nvPicPr>
        <p:blipFill>
          <a:blip r:embed="rId1"/>
          <a:stretch/>
        </p:blipFill>
        <p:spPr>
          <a:xfrm>
            <a:off x="1378080" y="2560680"/>
            <a:ext cx="5857920" cy="216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6T19:55:06Z</dcterms:created>
  <dc:creator>Prius Inc</dc:creator>
  <dc:description/>
  <dc:language>en-US</dc:language>
  <cp:lastModifiedBy>jose.lopezribot</cp:lastModifiedBy>
  <dcterms:modified xsi:type="dcterms:W3CDTF">2010-02-02T18:31:15Z</dcterms:modified>
  <cp:revision>1</cp:revision>
  <dc:subject/>
  <dc:title>Slide 1</dc:title>
</cp:coreProperties>
</file>